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3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2636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AC75DA-876C-9814-7DE4-179093D684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C5BA292-FE38-AEFF-D734-A5DE75EE37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341F4E-8D10-0C49-A11F-F8BB6ACDF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0E3A5-A250-A72D-0655-868102841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3E4995-1A25-5613-3CB7-F8F1FBCA1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16581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153C7E-249C-C608-C640-68C35A1FFF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6A180C-B2AB-BFA0-1DD2-C57FFCE6D5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D53947-AF88-AD42-11FB-5027FC770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91670A-E8BF-FBE7-B76E-6AAB0061A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D2F002-18E4-F467-0691-217B8C119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32921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9086AB-956A-6EF1-5DBB-DC43E5DBA1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4E7BCA-4ADA-1998-0E0E-F5021CC4F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248976-69F8-ED46-0B5C-F590C0710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7D4A30-63B2-A4DD-4502-3B1DDB582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78DD4B-AD6E-9022-46A0-57067D699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89813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56398-2E91-DCCA-7A89-1D84D13785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DCC001-5649-AB4E-6494-ACD12990FE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78D962-9ED6-6567-7417-E76244A7F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E149EF-7CD2-8C65-7EEB-76B4D83A3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18CDEF-2DDF-E3D9-3B5E-61A639C60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24205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F82F80-993F-D2FB-0DBA-485FD4D8FF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56A2D8-14C2-C746-3B1D-933005CAF8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1437D5-A396-81BA-47E0-EEEFE0AFB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855B5-4FF2-A87D-2D42-1C91F9C53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3100FB-51DD-A3CD-2E67-524D38891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73098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228DD7-A945-C1E3-815F-26FD23C195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54B4C6-90E7-8E99-6217-194852FC0D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02E0C6-144D-ECB8-72A3-2748FD7AE3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43D97D-D2D0-176E-562F-6CFEEC3FE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2ABEDC-26DF-E91A-B279-A0E42BB3A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0BB212-CE38-9BFC-1BEE-003AE576C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78442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006D5F-0CE7-3109-267A-DDE0F6EED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CE52BF-CBF4-9A79-43C2-00FD8F6046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ED3AA0-6116-EEB4-2ADD-46D16E7A9A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A17345-989F-CAFF-E538-29AECBE2AE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AAA2BB-06A9-515E-E6D7-40B6761B8A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4B79C1-3F57-F46E-C41E-754344EB6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D21308-54ED-803A-630E-076B9A425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E54443E-6521-6B03-E4A5-0DF282F47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99042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FE944-4B0A-DBE3-1026-336F0EA6D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D9B25A-F645-7109-DFD8-8A3E209DC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3639BA-8140-AFE8-E84A-5AE1DB01F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5D4F7E-18F3-E380-29A4-A761E131A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38731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ECAAC5-A8F4-D635-2AF1-B6AF071C8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0E0357-85EC-A8C4-13EE-E9DF67E41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465C70-5E4A-37F7-0442-2A0CBD8EE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56615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85375-7F61-062D-AB1C-DF9C5654B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03E477-406E-C5F5-4B78-E5E53C0548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7B9FAC-3F01-D384-6DA5-DF78FA169F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65789E-63D7-54B7-0C33-A70C241BF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87737B-EC50-0FEF-DA55-B81A8B1A3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094EC0-CEAE-21D8-8AE5-5B165533C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37477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DD1A9F-C6F0-792B-050C-29C4DFDFD9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E15C31-1847-8321-3FB3-09E6B813D7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3766E6-64D7-4E38-1599-707BD73E38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6E8DF5-E161-B255-0C7B-9FABBF9CC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A97C65-43FA-49B8-125B-AC7F7FA25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17EA60-AE12-BB00-E775-17EE0201D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42284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1378DE-852B-CFB7-9A7A-0835366275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1828B3-FE3D-3926-B625-63B9F59B69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B7AED3-ED14-68E6-52DD-3E815FF5F7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41B404-05E3-EF5C-F3ED-A45358ABC6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E35E14-3BAD-3053-0D55-C41CCC65FB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61670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8DFC016-54F1-41A3-AA30-4ED565AB008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910" t="-371" r="1305" b="54834"/>
          <a:stretch/>
        </p:blipFill>
        <p:spPr bwMode="auto">
          <a:xfrm>
            <a:off x="4260573" y="3026030"/>
            <a:ext cx="3902766" cy="2755232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C7184050-6299-4AA1-A8E3-7F7DDDC19684}"/>
              </a:ext>
            </a:extLst>
          </p:cNvPr>
          <p:cNvSpPr/>
          <p:nvPr/>
        </p:nvSpPr>
        <p:spPr>
          <a:xfrm>
            <a:off x="4552702" y="4061345"/>
            <a:ext cx="2772000" cy="30710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8C0A429-96C2-4B62-9E9E-D9B63BD9D183}"/>
              </a:ext>
            </a:extLst>
          </p:cNvPr>
          <p:cNvSpPr txBox="1"/>
          <p:nvPr/>
        </p:nvSpPr>
        <p:spPr>
          <a:xfrm>
            <a:off x="7847846" y="4061345"/>
            <a:ext cx="803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PK3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1856A46-A0E4-0008-ECBC-5B63481E9BBE}"/>
              </a:ext>
            </a:extLst>
          </p:cNvPr>
          <p:cNvSpPr txBox="1"/>
          <p:nvPr/>
        </p:nvSpPr>
        <p:spPr>
          <a:xfrm>
            <a:off x="1014222" y="1025027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2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62DE463-ABE6-FEC9-7FCF-7AEE923A4B46}"/>
              </a:ext>
            </a:extLst>
          </p:cNvPr>
          <p:cNvSpPr txBox="1"/>
          <p:nvPr/>
        </p:nvSpPr>
        <p:spPr>
          <a:xfrm rot="16200000">
            <a:off x="4603701" y="2541229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EFF2C5F-BF07-96E8-BE51-E3D8CC27ED94}"/>
              </a:ext>
            </a:extLst>
          </p:cNvPr>
          <p:cNvSpPr txBox="1"/>
          <p:nvPr/>
        </p:nvSpPr>
        <p:spPr>
          <a:xfrm rot="16200000">
            <a:off x="5241358" y="1331491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68EF877-9CD6-BC85-9634-0B11BCCC6269}"/>
              </a:ext>
            </a:extLst>
          </p:cNvPr>
          <p:cNvSpPr txBox="1"/>
          <p:nvPr/>
        </p:nvSpPr>
        <p:spPr>
          <a:xfrm rot="16200000">
            <a:off x="4781818" y="2252608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AB4F172-CE83-E1B6-1187-AD1A688A4323}"/>
              </a:ext>
            </a:extLst>
          </p:cNvPr>
          <p:cNvSpPr txBox="1"/>
          <p:nvPr/>
        </p:nvSpPr>
        <p:spPr>
          <a:xfrm rot="16200000">
            <a:off x="5541107" y="2132234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92971E1-7E70-5545-940C-3F6F76A63BBB}"/>
              </a:ext>
            </a:extLst>
          </p:cNvPr>
          <p:cNvSpPr txBox="1"/>
          <p:nvPr/>
        </p:nvSpPr>
        <p:spPr>
          <a:xfrm rot="16200000">
            <a:off x="5259496" y="2305358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EFE78C7-AA4B-815D-173E-30B1C2CCDD69}"/>
              </a:ext>
            </a:extLst>
          </p:cNvPr>
          <p:cNvSpPr txBox="1"/>
          <p:nvPr/>
        </p:nvSpPr>
        <p:spPr>
          <a:xfrm rot="16200000">
            <a:off x="5702204" y="1377748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66C169A5-144F-BE84-F483-04B18984DA0E}"/>
              </a:ext>
            </a:extLst>
          </p:cNvPr>
          <p:cNvCxnSpPr>
            <a:cxnSpLocks/>
          </p:cNvCxnSpPr>
          <p:nvPr/>
        </p:nvCxnSpPr>
        <p:spPr>
          <a:xfrm>
            <a:off x="4624394" y="288524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33AA480D-0219-E495-1BE9-85598886AA27}"/>
              </a:ext>
            </a:extLst>
          </p:cNvPr>
          <p:cNvCxnSpPr>
            <a:cxnSpLocks/>
          </p:cNvCxnSpPr>
          <p:nvPr/>
        </p:nvCxnSpPr>
        <p:spPr>
          <a:xfrm>
            <a:off x="5088220" y="288524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8259DE51-5E44-3F70-5135-83DFF33E015C}"/>
              </a:ext>
            </a:extLst>
          </p:cNvPr>
          <p:cNvCxnSpPr>
            <a:cxnSpLocks/>
          </p:cNvCxnSpPr>
          <p:nvPr/>
        </p:nvCxnSpPr>
        <p:spPr>
          <a:xfrm>
            <a:off x="5549065" y="288499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9DD9A90-617E-AC67-CF89-6EE39959EEF4}"/>
              </a:ext>
            </a:extLst>
          </p:cNvPr>
          <p:cNvCxnSpPr>
            <a:cxnSpLocks/>
          </p:cNvCxnSpPr>
          <p:nvPr/>
        </p:nvCxnSpPr>
        <p:spPr>
          <a:xfrm>
            <a:off x="6003545" y="288499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69ED3267-1442-D256-9E67-9D07442E08DD}"/>
              </a:ext>
            </a:extLst>
          </p:cNvPr>
          <p:cNvCxnSpPr>
            <a:cxnSpLocks/>
          </p:cNvCxnSpPr>
          <p:nvPr/>
        </p:nvCxnSpPr>
        <p:spPr>
          <a:xfrm>
            <a:off x="6453194" y="288740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DE7F4D3-0A07-CA61-9388-4E055F03439E}"/>
              </a:ext>
            </a:extLst>
          </p:cNvPr>
          <p:cNvCxnSpPr>
            <a:cxnSpLocks/>
          </p:cNvCxnSpPr>
          <p:nvPr/>
        </p:nvCxnSpPr>
        <p:spPr>
          <a:xfrm>
            <a:off x="6910394" y="288499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2564D195-097E-2455-355C-0C5091BCA224}"/>
              </a:ext>
            </a:extLst>
          </p:cNvPr>
          <p:cNvSpPr txBox="1"/>
          <p:nvPr/>
        </p:nvSpPr>
        <p:spPr>
          <a:xfrm>
            <a:off x="4034154" y="2920911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324BCE0-905E-A355-13E6-61F517DD342B}"/>
              </a:ext>
            </a:extLst>
          </p:cNvPr>
          <p:cNvSpPr txBox="1"/>
          <p:nvPr/>
        </p:nvSpPr>
        <p:spPr>
          <a:xfrm>
            <a:off x="3653349" y="3200378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DE3F02F-39F3-D382-4DD5-2D1F8B9A08B6}"/>
              </a:ext>
            </a:extLst>
          </p:cNvPr>
          <p:cNvSpPr txBox="1"/>
          <p:nvPr/>
        </p:nvSpPr>
        <p:spPr>
          <a:xfrm>
            <a:off x="4559789" y="2904185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606381A-F9AD-6E42-452A-F420FE9A5F50}"/>
              </a:ext>
            </a:extLst>
          </p:cNvPr>
          <p:cNvSpPr txBox="1"/>
          <p:nvPr/>
        </p:nvSpPr>
        <p:spPr>
          <a:xfrm>
            <a:off x="4559789" y="3153571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CBF34FA7-192D-401A-9787-46B59A9B98DD}"/>
              </a:ext>
            </a:extLst>
          </p:cNvPr>
          <p:cNvCxnSpPr>
            <a:cxnSpLocks/>
          </p:cNvCxnSpPr>
          <p:nvPr/>
        </p:nvCxnSpPr>
        <p:spPr>
          <a:xfrm>
            <a:off x="4171897" y="4542417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36">
            <a:extLst>
              <a:ext uri="{FF2B5EF4-FFF2-40B4-BE49-F238E27FC236}">
                <a16:creationId xmlns:a16="http://schemas.microsoft.com/office/drawing/2014/main" id="{015C0B8D-58E3-4DE6-BF19-454CE4EFE6F3}"/>
              </a:ext>
            </a:extLst>
          </p:cNvPr>
          <p:cNvSpPr txBox="1"/>
          <p:nvPr/>
        </p:nvSpPr>
        <p:spPr>
          <a:xfrm>
            <a:off x="3843511" y="440034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648850D4-1A6F-4202-BA77-74E331369C68}"/>
              </a:ext>
            </a:extLst>
          </p:cNvPr>
          <p:cNvCxnSpPr>
            <a:cxnSpLocks/>
          </p:cNvCxnSpPr>
          <p:nvPr/>
        </p:nvCxnSpPr>
        <p:spPr>
          <a:xfrm>
            <a:off x="4171897" y="476545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38">
            <a:extLst>
              <a:ext uri="{FF2B5EF4-FFF2-40B4-BE49-F238E27FC236}">
                <a16:creationId xmlns:a16="http://schemas.microsoft.com/office/drawing/2014/main" id="{17857408-0151-4A47-A829-79D29D6676A7}"/>
              </a:ext>
            </a:extLst>
          </p:cNvPr>
          <p:cNvSpPr txBox="1"/>
          <p:nvPr/>
        </p:nvSpPr>
        <p:spPr>
          <a:xfrm>
            <a:off x="3843511" y="462338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10E8EB3-7ABC-44AF-817B-43C42A7602A7}"/>
              </a:ext>
            </a:extLst>
          </p:cNvPr>
          <p:cNvCxnSpPr>
            <a:cxnSpLocks/>
          </p:cNvCxnSpPr>
          <p:nvPr/>
        </p:nvCxnSpPr>
        <p:spPr>
          <a:xfrm>
            <a:off x="4178033" y="419382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40">
            <a:extLst>
              <a:ext uri="{FF2B5EF4-FFF2-40B4-BE49-F238E27FC236}">
                <a16:creationId xmlns:a16="http://schemas.microsoft.com/office/drawing/2014/main" id="{4FBBD120-0B82-462B-A1A0-ADED2852B0B5}"/>
              </a:ext>
            </a:extLst>
          </p:cNvPr>
          <p:cNvSpPr txBox="1"/>
          <p:nvPr/>
        </p:nvSpPr>
        <p:spPr>
          <a:xfrm>
            <a:off x="3849647" y="405175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58655F5B-6626-43D2-B335-371BEE968A8D}"/>
              </a:ext>
            </a:extLst>
          </p:cNvPr>
          <p:cNvCxnSpPr>
            <a:cxnSpLocks/>
          </p:cNvCxnSpPr>
          <p:nvPr/>
        </p:nvCxnSpPr>
        <p:spPr>
          <a:xfrm>
            <a:off x="4171897" y="398902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2">
            <a:extLst>
              <a:ext uri="{FF2B5EF4-FFF2-40B4-BE49-F238E27FC236}">
                <a16:creationId xmlns:a16="http://schemas.microsoft.com/office/drawing/2014/main" id="{914F6FFB-42E7-41F6-B136-B2A94CF3501B}"/>
              </a:ext>
            </a:extLst>
          </p:cNvPr>
          <p:cNvSpPr txBox="1"/>
          <p:nvPr/>
        </p:nvSpPr>
        <p:spPr>
          <a:xfrm>
            <a:off x="3843511" y="384018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4DC44C71-8904-48A6-BFEC-21720B43FB9B}"/>
              </a:ext>
            </a:extLst>
          </p:cNvPr>
          <p:cNvCxnSpPr>
            <a:cxnSpLocks/>
          </p:cNvCxnSpPr>
          <p:nvPr/>
        </p:nvCxnSpPr>
        <p:spPr>
          <a:xfrm>
            <a:off x="4171897" y="387478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42">
            <a:extLst>
              <a:ext uri="{FF2B5EF4-FFF2-40B4-BE49-F238E27FC236}">
                <a16:creationId xmlns:a16="http://schemas.microsoft.com/office/drawing/2014/main" id="{2CA58868-248F-4A84-8F93-6A902DF23820}"/>
              </a:ext>
            </a:extLst>
          </p:cNvPr>
          <p:cNvSpPr txBox="1"/>
          <p:nvPr/>
        </p:nvSpPr>
        <p:spPr>
          <a:xfrm>
            <a:off x="3758551" y="370728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0280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6</cp:revision>
  <dcterms:created xsi:type="dcterms:W3CDTF">2024-08-13T14:15:55Z</dcterms:created>
  <dcterms:modified xsi:type="dcterms:W3CDTF">2024-08-14T21:56:58Z</dcterms:modified>
</cp:coreProperties>
</file>